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0" r:id="rId2"/>
    <p:sldId id="258" r:id="rId3"/>
  </p:sldIdLst>
  <p:sldSz cx="6858000" cy="9144000" type="overhead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93" d="100"/>
          <a:sy n="93" d="100"/>
        </p:scale>
        <p:origin x="3408" y="2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216096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166281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076432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378961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597340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123410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287627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774154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88904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827199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847551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C2B9C-6A4F-8A45-8613-9031010D7368}" type="datetimeFigureOut">
              <a:rPr lang="x-none" smtClean="0"/>
              <a:t>2022-04-2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194EE-C035-884E-86BF-D64793EE558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466884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D9E29F-EFCB-A445-A5E6-6D1F4F674B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54049" y="4945962"/>
            <a:ext cx="5915025" cy="2478653"/>
          </a:xfrm>
        </p:spPr>
        <p:txBody>
          <a:bodyPr>
            <a:noAutofit/>
          </a:bodyPr>
          <a:lstStyle/>
          <a:p>
            <a:pPr marL="0" indent="0" algn="just">
              <a:lnSpc>
                <a:spcPct val="130000"/>
              </a:lnSpc>
              <a:spcBef>
                <a:spcPts val="0"/>
              </a:spcBef>
              <a:buNone/>
            </a:pP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ure S1. Ectopic expression of MYH13 identified as a candidate gene in Family 1 and its biological effects analyzed by KEGG pathway analysis. </a:t>
            </a:r>
          </a:p>
          <a:p>
            <a:pPr marL="0" indent="0" algn="just">
              <a:lnSpc>
                <a:spcPct val="130000"/>
              </a:lnSpc>
              <a:spcBef>
                <a:spcPts val="0"/>
              </a:spcBef>
              <a:buNone/>
            </a:pP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 MDA-MB-231 and MCF-7 cell lines were transfected with wild-type </a:t>
            </a:r>
            <a:r>
              <a:rPr lang="en-US" sz="11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YH13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plasmid (WT), Q1857R mutant </a:t>
            </a:r>
            <a:r>
              <a:rPr lang="en-US" sz="11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YH13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plasmid (</a:t>
            </a:r>
            <a:r>
              <a:rPr lang="en-US" sz="11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ut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 or negative control plasmid (Neg.). The expression of mutant and wild-type MYH13 protein were comparable in both cell lines. GAPDH was used as a loading control and the protein sizes are indicated  to the right in </a:t>
            </a:r>
            <a:r>
              <a:rPr lang="en-US" sz="11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(</a:t>
            </a: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 KEGG pathway analysis of differentially expressed proteins between WT and </a:t>
            </a:r>
            <a:r>
              <a:rPr lang="en-US" sz="11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ut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MYH13 in MCF-7 showed enrichment of proteins associated with seven pathways. The pathways “DNA replication” and “protein processing in endoplasmic reticulum” showed an adjusted </a:t>
            </a:r>
            <a:r>
              <a:rPr lang="en-US" sz="11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 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value </a:t>
            </a:r>
            <a:r>
              <a:rPr lang="zh-CN" alt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≤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05 (dark blue) while the remaining five pathways had an adjusted </a:t>
            </a:r>
            <a:r>
              <a:rPr lang="en-US" sz="11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 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value &gt;0.05 (light blue). The enrichment ratio indicates the number of observed proteins divided by the number of expected proteins from KEGG category in each pathway. </a:t>
            </a:r>
            <a:endParaRPr lang="x-none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just">
              <a:lnSpc>
                <a:spcPct val="130000"/>
              </a:lnSpc>
              <a:spcBef>
                <a:spcPts val="0"/>
              </a:spcBef>
              <a:buNone/>
            </a:pPr>
            <a:endParaRPr lang="x-non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8E1A1DC-A372-DA4E-9E6E-4450A844A59A}"/>
              </a:ext>
            </a:extLst>
          </p:cNvPr>
          <p:cNvGrpSpPr/>
          <p:nvPr/>
        </p:nvGrpSpPr>
        <p:grpSpPr>
          <a:xfrm>
            <a:off x="1376801" y="1191779"/>
            <a:ext cx="4490265" cy="1173195"/>
            <a:chOff x="4211208" y="2653359"/>
            <a:chExt cx="4490265" cy="1173195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168A177B-899B-A94A-8C37-C36C4B76B4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062" t="44715" r="27465" b="51867"/>
            <a:stretch/>
          </p:blipFill>
          <p:spPr>
            <a:xfrm>
              <a:off x="4769533" y="3130892"/>
              <a:ext cx="3094074" cy="319555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5F3FE0D-4E44-F849-A68C-B766377805A4}"/>
                </a:ext>
              </a:extLst>
            </p:cNvPr>
            <p:cNvSpPr txBox="1"/>
            <p:nvPr/>
          </p:nvSpPr>
          <p:spPr>
            <a:xfrm>
              <a:off x="4221513" y="2882639"/>
              <a:ext cx="370265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               </a:t>
              </a: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B231  Neg.        WT         </a:t>
              </a:r>
              <a:r>
                <a:rPr kumimoji="0" lang="en-US" sz="9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ut</a:t>
              </a: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      Neg.        WT       </a:t>
              </a:r>
              <a:r>
                <a:rPr kumimoji="0" lang="en-US" sz="9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ut</a:t>
              </a: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    MCF-7   </a:t>
              </a:r>
              <a:endParaRPr kumimoji="0" lang="sv-SE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2C2F62C-AA3D-394D-96C6-BBC5C902AC88}"/>
                </a:ext>
              </a:extLst>
            </p:cNvPr>
            <p:cNvSpPr txBox="1"/>
            <p:nvPr/>
          </p:nvSpPr>
          <p:spPr>
            <a:xfrm>
              <a:off x="4211208" y="3138043"/>
              <a:ext cx="872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YH13</a:t>
              </a:r>
              <a:endParaRPr kumimoji="0" lang="sv-SE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70AF6214-C9B7-594B-8941-7F565B54287A}"/>
                </a:ext>
              </a:extLst>
            </p:cNvPr>
            <p:cNvGrpSpPr/>
            <p:nvPr/>
          </p:nvGrpSpPr>
          <p:grpSpPr>
            <a:xfrm>
              <a:off x="4731359" y="2656072"/>
              <a:ext cx="1447800" cy="243345"/>
              <a:chOff x="4757117" y="2656072"/>
              <a:chExt cx="1447800" cy="243345"/>
            </a:xfrm>
          </p:grpSpPr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99B73ABC-C59C-C246-BCC2-5F32D592380C}"/>
                  </a:ext>
                </a:extLst>
              </p:cNvPr>
              <p:cNvCxnSpPr/>
              <p:nvPr/>
            </p:nvCxnSpPr>
            <p:spPr>
              <a:xfrm>
                <a:off x="4757117" y="2899417"/>
                <a:ext cx="14478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0F35D43B-3C63-1D4A-AD6E-CA49FDA6942C}"/>
                  </a:ext>
                </a:extLst>
              </p:cNvPr>
              <p:cNvSpPr/>
              <p:nvPr/>
            </p:nvSpPr>
            <p:spPr>
              <a:xfrm>
                <a:off x="5215299" y="2656072"/>
                <a:ext cx="545342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MB231 </a:t>
                </a:r>
                <a:endParaRPr kumimoji="0" lang="sv-SE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7E50D439-2582-2446-A178-F844CB82E1FC}"/>
                </a:ext>
              </a:extLst>
            </p:cNvPr>
            <p:cNvGrpSpPr/>
            <p:nvPr/>
          </p:nvGrpSpPr>
          <p:grpSpPr>
            <a:xfrm>
              <a:off x="6350278" y="2653359"/>
              <a:ext cx="1347211" cy="246058"/>
              <a:chOff x="6350278" y="2653359"/>
              <a:chExt cx="1347211" cy="246058"/>
            </a:xfrm>
          </p:grpSpPr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FD96514D-2763-4F46-AF61-CBF93CA02876}"/>
                  </a:ext>
                </a:extLst>
              </p:cNvPr>
              <p:cNvCxnSpPr/>
              <p:nvPr/>
            </p:nvCxnSpPr>
            <p:spPr>
              <a:xfrm>
                <a:off x="6350278" y="2899417"/>
                <a:ext cx="1347211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6034E06D-4D0D-BD4C-9C17-C9633E86D3E3}"/>
                  </a:ext>
                </a:extLst>
              </p:cNvPr>
              <p:cNvSpPr/>
              <p:nvPr/>
            </p:nvSpPr>
            <p:spPr>
              <a:xfrm>
                <a:off x="6732672" y="2653359"/>
                <a:ext cx="517840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 MCF-7 </a:t>
                </a:r>
                <a:endParaRPr kumimoji="0" lang="sv-SE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D4B338C-E31F-E94E-A572-EC31FB5F56BD}"/>
                </a:ext>
              </a:extLst>
            </p:cNvPr>
            <p:cNvSpPr txBox="1"/>
            <p:nvPr/>
          </p:nvSpPr>
          <p:spPr>
            <a:xfrm>
              <a:off x="7819079" y="3142697"/>
              <a:ext cx="872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50 </a:t>
              </a:r>
              <a:r>
                <a:rPr kumimoji="0" lang="en-US" sz="9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kDa</a:t>
              </a:r>
              <a:endParaRPr kumimoji="0" lang="sv-SE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8D807B4-5D62-7544-AFC4-3ACBBF686487}"/>
                </a:ext>
              </a:extLst>
            </p:cNvPr>
            <p:cNvSpPr txBox="1"/>
            <p:nvPr/>
          </p:nvSpPr>
          <p:spPr>
            <a:xfrm>
              <a:off x="4211208" y="3457222"/>
              <a:ext cx="872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GAPDH</a:t>
              </a:r>
              <a:endParaRPr kumimoji="0" lang="sv-SE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C52E91F-7CED-8040-8938-F27AD27B1D0C}"/>
                </a:ext>
              </a:extLst>
            </p:cNvPr>
            <p:cNvSpPr txBox="1"/>
            <p:nvPr/>
          </p:nvSpPr>
          <p:spPr>
            <a:xfrm>
              <a:off x="7829049" y="3428924"/>
              <a:ext cx="8724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7 </a:t>
              </a:r>
              <a:r>
                <a:rPr kumimoji="0" lang="en-US" sz="9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kDa</a:t>
              </a:r>
              <a:endParaRPr kumimoji="0" lang="sv-SE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pic>
        <p:nvPicPr>
          <p:cNvPr id="34" name="Picture 33">
            <a:extLst>
              <a:ext uri="{FF2B5EF4-FFF2-40B4-BE49-F238E27FC236}">
                <a16:creationId xmlns:a16="http://schemas.microsoft.com/office/drawing/2014/main" id="{0313FDFC-D1EB-BE4B-B49E-E5315267388E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125" y="2962012"/>
            <a:ext cx="6492875" cy="1853565"/>
          </a:xfrm>
          <a:prstGeom prst="rect">
            <a:avLst/>
          </a:prstGeom>
          <a:noFill/>
        </p:spPr>
      </p:pic>
      <p:sp>
        <p:nvSpPr>
          <p:cNvPr id="35" name="TextBox 1">
            <a:extLst>
              <a:ext uri="{FF2B5EF4-FFF2-40B4-BE49-F238E27FC236}">
                <a16:creationId xmlns:a16="http://schemas.microsoft.com/office/drawing/2014/main" id="{34A75F97-10D0-DF45-B080-517A1B87B2F1}"/>
              </a:ext>
            </a:extLst>
          </p:cNvPr>
          <p:cNvSpPr txBox="1"/>
          <p:nvPr/>
        </p:nvSpPr>
        <p:spPr>
          <a:xfrm>
            <a:off x="901812" y="2534467"/>
            <a:ext cx="266065" cy="277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x-none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x-none" sz="1200" b="1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6" name="TextBox 1">
            <a:extLst>
              <a:ext uri="{FF2B5EF4-FFF2-40B4-BE49-F238E27FC236}">
                <a16:creationId xmlns:a16="http://schemas.microsoft.com/office/drawing/2014/main" id="{DD9B65AA-5A88-C945-B925-6C9F431EB052}"/>
              </a:ext>
            </a:extLst>
          </p:cNvPr>
          <p:cNvSpPr txBox="1"/>
          <p:nvPr/>
        </p:nvSpPr>
        <p:spPr>
          <a:xfrm>
            <a:off x="901812" y="723652"/>
            <a:ext cx="266065" cy="277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x-none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x-none" sz="1200" b="1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62" t="46534" r="12521" b="46472"/>
          <a:stretch/>
        </p:blipFill>
        <p:spPr>
          <a:xfrm>
            <a:off x="1932414" y="1945758"/>
            <a:ext cx="3108960" cy="3199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9115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07C4DE-AF47-3447-B8DA-EE66ACEF72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8" y="4994788"/>
            <a:ext cx="5915025" cy="3240674"/>
          </a:xfrm>
        </p:spPr>
        <p:txBody>
          <a:bodyPr>
            <a:normAutofit/>
          </a:bodyPr>
          <a:lstStyle/>
          <a:p>
            <a:pPr marL="0" indent="0" algn="just">
              <a:lnSpc>
                <a:spcPct val="130000"/>
              </a:lnSpc>
              <a:spcBef>
                <a:spcPts val="0"/>
              </a:spcBef>
              <a:buNone/>
            </a:pP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ure S2. Ectopic expression of UTP11L identified as a candidate gene in Family 2  and its biological effects analyzed by KEGG pathway database. </a:t>
            </a:r>
          </a:p>
          <a:p>
            <a:pPr marL="0" indent="0" algn="just">
              <a:lnSpc>
                <a:spcPct val="130000"/>
              </a:lnSpc>
              <a:spcBef>
                <a:spcPts val="0"/>
              </a:spcBef>
              <a:buNone/>
            </a:pP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. MDA-MB-231 and MCF-7 cell lines were transfected with wild-type </a:t>
            </a:r>
            <a:r>
              <a:rPr lang="en-US" sz="11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UTP11L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plasmid (WT), R253C mutant </a:t>
            </a:r>
            <a:r>
              <a:rPr lang="en-US" sz="11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UTP11L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plasmid (</a:t>
            </a:r>
            <a:r>
              <a:rPr lang="en-US" sz="11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ut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 or negative control plasmid (Neg.). The expression of mutant and wild-type UTP11L protein were comparable in both cell lines. GAPDH was used as a loading control and the protein sizes are indicated  to the right in </a:t>
            </a:r>
            <a:r>
              <a:rPr lang="en-US" sz="11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(</a:t>
            </a:r>
            <a:r>
              <a:rPr lang="en-US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 B. KEGG pathway analysis of differentially expressed proteins between WT and </a:t>
            </a:r>
            <a:r>
              <a:rPr lang="en-US" sz="11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ut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UTP11L in MCF-7 showed enrichment of proteins associated with six pathways. The adjusted </a:t>
            </a:r>
            <a:r>
              <a:rPr lang="en-US" sz="11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 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value was &gt;0.05 (light blue) for all pathways. The enrichment ratio indicates the number of observed proteins divided by the number of expected proteins from KEGG category in each pathway. </a:t>
            </a:r>
            <a:endParaRPr lang="x-none" sz="11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 marL="342900" indent="-342900" algn="just">
              <a:lnSpc>
                <a:spcPct val="107000"/>
              </a:lnSpc>
              <a:spcAft>
                <a:spcPts val="800"/>
              </a:spcAft>
              <a:buAutoNum type="alphaUcPeriod"/>
            </a:pPr>
            <a:endParaRPr lang="x-none" sz="1200" dirty="0"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endParaRPr lang="x-none" sz="1600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D591158-2A39-CA47-91C2-30BF977DC9DB}"/>
              </a:ext>
            </a:extLst>
          </p:cNvPr>
          <p:cNvGrpSpPr/>
          <p:nvPr/>
        </p:nvGrpSpPr>
        <p:grpSpPr>
          <a:xfrm>
            <a:off x="1202579" y="1018287"/>
            <a:ext cx="4099610" cy="1254292"/>
            <a:chOff x="6561159" y="1677049"/>
            <a:chExt cx="4099610" cy="1254292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DF7C6710-C7C5-954A-BC45-FA8C0FD4E318}"/>
                </a:ext>
              </a:extLst>
            </p:cNvPr>
            <p:cNvGrpSpPr/>
            <p:nvPr/>
          </p:nvGrpSpPr>
          <p:grpSpPr>
            <a:xfrm>
              <a:off x="6958903" y="1677049"/>
              <a:ext cx="3327920" cy="700765"/>
              <a:chOff x="5040063" y="820705"/>
              <a:chExt cx="3327920" cy="700765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B538F17B-C7F7-494A-ABA3-B0149847465F}"/>
                  </a:ext>
                </a:extLst>
              </p:cNvPr>
              <p:cNvGrpSpPr/>
              <p:nvPr/>
            </p:nvGrpSpPr>
            <p:grpSpPr>
              <a:xfrm>
                <a:off x="5040063" y="919543"/>
                <a:ext cx="1867830" cy="601927"/>
                <a:chOff x="2929414" y="1497338"/>
                <a:chExt cx="1867830" cy="601927"/>
              </a:xfrm>
            </p:grpSpPr>
            <p:cxnSp>
              <p:nvCxnSpPr>
                <p:cNvPr id="20" name="Straight Connector 19">
                  <a:extLst>
                    <a:ext uri="{FF2B5EF4-FFF2-40B4-BE49-F238E27FC236}">
                      <a16:creationId xmlns:a16="http://schemas.microsoft.com/office/drawing/2014/main" id="{4447BADA-B757-7C47-AD65-EDB8546979AB}"/>
                    </a:ext>
                  </a:extLst>
                </p:cNvPr>
                <p:cNvCxnSpPr/>
                <p:nvPr/>
              </p:nvCxnSpPr>
              <p:spPr>
                <a:xfrm>
                  <a:off x="3022709" y="1716279"/>
                  <a:ext cx="14478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3CAD9FDE-9D47-0C43-BD39-2A52D2B3FEFE}"/>
                    </a:ext>
                  </a:extLst>
                </p:cNvPr>
                <p:cNvSpPr/>
                <p:nvPr/>
              </p:nvSpPr>
              <p:spPr>
                <a:xfrm>
                  <a:off x="3506622" y="1497338"/>
                  <a:ext cx="570990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/>
                    <a:t>MB231  </a:t>
                  </a:r>
                  <a:endParaRPr lang="sv-SE" sz="900" dirty="0"/>
                </a:p>
              </p:txBody>
            </p:sp>
            <p:sp>
              <p:nvSpPr>
                <p:cNvPr id="22" name="TextBox 6">
                  <a:extLst>
                    <a:ext uri="{FF2B5EF4-FFF2-40B4-BE49-F238E27FC236}">
                      <a16:creationId xmlns:a16="http://schemas.microsoft.com/office/drawing/2014/main" id="{6BDD6875-73CF-FB40-98E4-E2764D710184}"/>
                    </a:ext>
                  </a:extLst>
                </p:cNvPr>
                <p:cNvSpPr txBox="1"/>
                <p:nvPr/>
              </p:nvSpPr>
              <p:spPr>
                <a:xfrm>
                  <a:off x="2929414" y="1706850"/>
                  <a:ext cx="1867830" cy="392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MB231</a:t>
                  </a:r>
                  <a:r>
                    <a:rPr lang="en-US" sz="1050" dirty="0"/>
                    <a:t>     </a:t>
                  </a:r>
                  <a:r>
                    <a:rPr lang="en-US" sz="900" dirty="0"/>
                    <a:t>Neg.      WT      </a:t>
                  </a:r>
                  <a:r>
                    <a:rPr lang="en-US" sz="900" dirty="0" err="1"/>
                    <a:t>Mut</a:t>
                  </a:r>
                  <a:r>
                    <a:rPr lang="en-US" sz="900" dirty="0"/>
                    <a:t>           </a:t>
                  </a:r>
                  <a:endParaRPr lang="sv-SE" sz="900" dirty="0"/>
                </a:p>
                <a:p>
                  <a:endParaRPr lang="en-US" sz="900" dirty="0"/>
                </a:p>
              </p:txBody>
            </p:sp>
          </p:grp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3985E48E-5571-EE4A-8426-CAC8B6C5D3FA}"/>
                  </a:ext>
                </a:extLst>
              </p:cNvPr>
              <p:cNvGrpSpPr/>
              <p:nvPr/>
            </p:nvGrpSpPr>
            <p:grpSpPr>
              <a:xfrm>
                <a:off x="6596126" y="820705"/>
                <a:ext cx="1771857" cy="675655"/>
                <a:chOff x="5840350" y="1393507"/>
                <a:chExt cx="1771857" cy="675655"/>
              </a:xfrm>
            </p:grpSpPr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35001AFF-14C8-9546-9D40-D6951C755E60}"/>
                    </a:ext>
                  </a:extLst>
                </p:cNvPr>
                <p:cNvSpPr txBox="1"/>
                <p:nvPr/>
              </p:nvSpPr>
              <p:spPr>
                <a:xfrm>
                  <a:off x="5840350" y="1699830"/>
                  <a:ext cx="177185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Neg.       </a:t>
                  </a:r>
                  <a:r>
                    <a:rPr lang="en-US" sz="900" dirty="0" err="1"/>
                    <a:t>Wt</a:t>
                  </a:r>
                  <a:r>
                    <a:rPr lang="en-US" sz="900" dirty="0"/>
                    <a:t>       </a:t>
                  </a:r>
                  <a:r>
                    <a:rPr lang="en-US" sz="900" dirty="0" err="1"/>
                    <a:t>Mut</a:t>
                  </a:r>
                  <a:r>
                    <a:rPr lang="en-US" sz="900" dirty="0"/>
                    <a:t>    MCF-7    </a:t>
                  </a:r>
                  <a:endParaRPr lang="sv-SE" sz="900" dirty="0"/>
                </a:p>
                <a:p>
                  <a:endParaRPr lang="en-US" sz="900" dirty="0"/>
                </a:p>
              </p:txBody>
            </p:sp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6A3AD63C-DC36-BB46-A1E6-0971A15517E3}"/>
                    </a:ext>
                  </a:extLst>
                </p:cNvPr>
                <p:cNvGrpSpPr/>
                <p:nvPr/>
              </p:nvGrpSpPr>
              <p:grpSpPr>
                <a:xfrm>
                  <a:off x="5869788" y="1393507"/>
                  <a:ext cx="1407986" cy="338554"/>
                  <a:chOff x="6477000" y="2585320"/>
                  <a:chExt cx="1407986" cy="338554"/>
                </a:xfrm>
              </p:grpSpPr>
              <p:cxnSp>
                <p:nvCxnSpPr>
                  <p:cNvPr id="18" name="Straight Connector 17">
                    <a:extLst>
                      <a:ext uri="{FF2B5EF4-FFF2-40B4-BE49-F238E27FC236}">
                        <a16:creationId xmlns:a16="http://schemas.microsoft.com/office/drawing/2014/main" id="{6CBA8790-38D8-9841-AB56-D2DDC888557E}"/>
                      </a:ext>
                    </a:extLst>
                  </p:cNvPr>
                  <p:cNvCxnSpPr/>
                  <p:nvPr/>
                </p:nvCxnSpPr>
                <p:spPr>
                  <a:xfrm>
                    <a:off x="6477000" y="2899417"/>
                    <a:ext cx="1407986" cy="368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" name="Rectangle 18">
                    <a:extLst>
                      <a:ext uri="{FF2B5EF4-FFF2-40B4-BE49-F238E27FC236}">
                        <a16:creationId xmlns:a16="http://schemas.microsoft.com/office/drawing/2014/main" id="{463B9A25-634E-7F49-8805-17063A03208C}"/>
                      </a:ext>
                    </a:extLst>
                  </p:cNvPr>
                  <p:cNvSpPr/>
                  <p:nvPr/>
                </p:nvSpPr>
                <p:spPr>
                  <a:xfrm>
                    <a:off x="6895045" y="2585320"/>
                    <a:ext cx="553357" cy="338554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600" dirty="0"/>
                      <a:t> </a:t>
                    </a:r>
                    <a:r>
                      <a:rPr lang="en-US" sz="900" dirty="0"/>
                      <a:t>MCF-7  </a:t>
                    </a:r>
                    <a:endParaRPr lang="sv-SE" sz="900" dirty="0"/>
                  </a:p>
                </p:txBody>
              </p:sp>
            </p:grpSp>
          </p:grp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502E027-8BEC-3243-89E5-CA662E872174}"/>
                </a:ext>
              </a:extLst>
            </p:cNvPr>
            <p:cNvSpPr txBox="1"/>
            <p:nvPr/>
          </p:nvSpPr>
          <p:spPr>
            <a:xfrm>
              <a:off x="6561159" y="2244646"/>
              <a:ext cx="653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UTP11L</a:t>
              </a:r>
              <a:endParaRPr lang="sv-SE" sz="900" dirty="0"/>
            </a:p>
            <a:p>
              <a:endParaRPr lang="en-US" sz="9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1DEDB8D-5734-6247-B6BB-0288888EF27F}"/>
                </a:ext>
              </a:extLst>
            </p:cNvPr>
            <p:cNvSpPr txBox="1"/>
            <p:nvPr/>
          </p:nvSpPr>
          <p:spPr>
            <a:xfrm>
              <a:off x="6573859" y="2562009"/>
              <a:ext cx="653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GAPDH</a:t>
              </a:r>
              <a:endParaRPr lang="sv-SE" sz="900" dirty="0"/>
            </a:p>
            <a:p>
              <a:endParaRPr lang="en-US" sz="9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FBCBBF0-6F94-EC40-A3BD-F23247184C67}"/>
                </a:ext>
              </a:extLst>
            </p:cNvPr>
            <p:cNvSpPr txBox="1"/>
            <p:nvPr/>
          </p:nvSpPr>
          <p:spPr>
            <a:xfrm>
              <a:off x="10007617" y="2496330"/>
              <a:ext cx="653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37 </a:t>
              </a:r>
              <a:r>
                <a:rPr lang="en-US" sz="900" dirty="0" err="1"/>
                <a:t>kDa</a:t>
              </a:r>
              <a:endParaRPr lang="sv-SE" sz="900" dirty="0"/>
            </a:p>
            <a:p>
              <a:endParaRPr lang="en-US" sz="90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3063620-DF54-CD43-84C4-FE6C925C2F98}"/>
                </a:ext>
              </a:extLst>
            </p:cNvPr>
            <p:cNvSpPr txBox="1"/>
            <p:nvPr/>
          </p:nvSpPr>
          <p:spPr>
            <a:xfrm>
              <a:off x="9999182" y="2189500"/>
              <a:ext cx="653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30 </a:t>
              </a:r>
              <a:r>
                <a:rPr lang="en-US" sz="900" dirty="0" err="1"/>
                <a:t>kDa</a:t>
              </a:r>
              <a:endParaRPr lang="sv-SE" sz="900" dirty="0"/>
            </a:p>
            <a:p>
              <a:endParaRPr lang="en-US" sz="900" dirty="0"/>
            </a:p>
          </p:txBody>
        </p:sp>
      </p:grpSp>
      <p:sp>
        <p:nvSpPr>
          <p:cNvPr id="23" name="TextBox 1">
            <a:extLst>
              <a:ext uri="{FF2B5EF4-FFF2-40B4-BE49-F238E27FC236}">
                <a16:creationId xmlns:a16="http://schemas.microsoft.com/office/drawing/2014/main" id="{DE8E221B-C7F1-3A48-B9A6-9A821D7F2653}"/>
              </a:ext>
            </a:extLst>
          </p:cNvPr>
          <p:cNvSpPr txBox="1"/>
          <p:nvPr/>
        </p:nvSpPr>
        <p:spPr>
          <a:xfrm>
            <a:off x="901812" y="723652"/>
            <a:ext cx="266065" cy="277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x-none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x-none" sz="1200" b="1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0D5481A5-74BA-5D4D-9B4A-C3C8D6F5C304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562" y="2881563"/>
            <a:ext cx="6492875" cy="1755775"/>
          </a:xfrm>
          <a:prstGeom prst="rect">
            <a:avLst/>
          </a:prstGeom>
          <a:noFill/>
        </p:spPr>
      </p:pic>
      <p:sp>
        <p:nvSpPr>
          <p:cNvPr id="25" name="TextBox 1">
            <a:extLst>
              <a:ext uri="{FF2B5EF4-FFF2-40B4-BE49-F238E27FC236}">
                <a16:creationId xmlns:a16="http://schemas.microsoft.com/office/drawing/2014/main" id="{B778417D-000F-4F44-898F-4B055CE81A78}"/>
              </a:ext>
            </a:extLst>
          </p:cNvPr>
          <p:cNvSpPr txBox="1"/>
          <p:nvPr/>
        </p:nvSpPr>
        <p:spPr>
          <a:xfrm>
            <a:off x="901811" y="2385366"/>
            <a:ext cx="266065" cy="277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x-none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x-none" sz="1200" b="1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90" t="52634" r="51784" b="38933"/>
          <a:stretch/>
        </p:blipFill>
        <p:spPr>
          <a:xfrm>
            <a:off x="1705232" y="1565189"/>
            <a:ext cx="1495438" cy="343686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050" t="52713" r="20222" b="42236"/>
          <a:stretch/>
        </p:blipFill>
        <p:spPr>
          <a:xfrm>
            <a:off x="3151724" y="1882833"/>
            <a:ext cx="1503403" cy="279341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41" t="52451" r="43283" b="42589"/>
          <a:stretch/>
        </p:blipFill>
        <p:spPr>
          <a:xfrm>
            <a:off x="1704365" y="1864458"/>
            <a:ext cx="1477340" cy="297717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00" t="53299" r="18429" b="38587"/>
          <a:stretch/>
        </p:blipFill>
        <p:spPr>
          <a:xfrm>
            <a:off x="3185997" y="1564105"/>
            <a:ext cx="1463040" cy="3187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2631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1</TotalTime>
  <Words>379</Words>
  <Application>Microsoft Macintosh PowerPoint</Application>
  <PresentationFormat>Overhead</PresentationFormat>
  <Paragraphs>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3</cp:revision>
  <dcterms:created xsi:type="dcterms:W3CDTF">2020-11-25T19:49:51Z</dcterms:created>
  <dcterms:modified xsi:type="dcterms:W3CDTF">2022-04-26T13:17:41Z</dcterms:modified>
</cp:coreProperties>
</file>